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 /><Relationship Id="rId2" Type="http://schemas.openxmlformats.org/package/2006/relationships/metadata/thumbnail" Target="docProps/thumbnail.jpeg" /><Relationship Id="rId1" Type="http://schemas.openxmlformats.org/officeDocument/2006/relationships/officeDocument" Target="ppt/presentation.xml" /><Relationship Id="rId4" Type="http://schemas.openxmlformats.org/officeDocument/2006/relationships/extended-properties" Target="docProps/app.xml" 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 /><Relationship Id="rId7" Type="http://schemas.openxmlformats.org/officeDocument/2006/relationships/tableStyles" Target="tableStyles.xml" /><Relationship Id="rId2" Type="http://schemas.openxmlformats.org/officeDocument/2006/relationships/slide" Target="slides/slide1.xml" /><Relationship Id="rId1" Type="http://schemas.openxmlformats.org/officeDocument/2006/relationships/slideMaster" Target="slideMasters/slideMaster1.xml" /><Relationship Id="rId6" Type="http://schemas.openxmlformats.org/officeDocument/2006/relationships/theme" Target="theme/theme1.xml" /><Relationship Id="rId5" Type="http://schemas.openxmlformats.org/officeDocument/2006/relationships/viewProps" Target="viewProps.xml" /><Relationship Id="rId4" Type="http://schemas.openxmlformats.org/officeDocument/2006/relationships/presProps" Target="presProps.xml" 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8970CA-DD60-3B62-35B8-0D8494CD75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D278086-DEFF-0624-915F-671B3DA3B0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5BBA95-412F-B435-CED5-90AAE7EB15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3CC56-42FD-CF40-A71F-C19DE595C6B7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67882C-DDDA-AACF-1C7F-5E01B1EB7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8CD2DA-41EB-DB80-BF7A-0B0AB0730E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6BEE9-4D04-DE47-96E5-309095A37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939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0843F-8AB0-5986-C8F8-8C5B52A966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923654-4200-AB35-9583-BF69506E27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22C7C0-A202-0802-56CA-10C00C207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3CC56-42FD-CF40-A71F-C19DE595C6B7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50CCC7-0BF9-BF87-34DF-B71449181E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139960-5452-E8C0-D0E8-A59990591B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6BEE9-4D04-DE47-96E5-309095A37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073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7164563-F2A4-DB4D-3D1E-AC03BB944B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BAD2B4-12F9-79CB-A606-137CC1047D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23F2B1-ACAC-D822-3AF7-CC1F49DCD4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3CC56-42FD-CF40-A71F-C19DE595C6B7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52A88E-2E35-DBDC-788E-17F09CD5BA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655D77-8EB0-8C31-A8B0-468F09E6D9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6BEE9-4D04-DE47-96E5-309095A37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478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6B1AC4-771D-EC75-4493-D063AE34C1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171531-374E-97C9-3230-57D85D8E8A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EE285A-AFCD-DCFA-8B8F-BAF4047D95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3CC56-42FD-CF40-A71F-C19DE595C6B7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22308E-3F58-DE87-7C5C-F7CBB78FD9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923DF8-75B3-7253-E2ED-0EDF20753D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6BEE9-4D04-DE47-96E5-309095A37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771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3BA1D8-D1A4-2527-D7A7-4AACBC8BBC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E73972-7FD1-B4BA-1BCC-19D14B097C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0F34AF-043C-E17E-0B8E-92E2D1DA4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3CC56-42FD-CF40-A71F-C19DE595C6B7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199B1D-C342-098C-B313-3B79451552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AACCBD-C9D9-8ABD-F01F-CEBA252C9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6BEE9-4D04-DE47-96E5-309095A37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350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7CA9D5-2DBE-9FAB-0BD3-EEB4EF4AD0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593827-EF7B-09BF-0836-3B95661B7A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C61047-37CD-A912-65A5-6F252D48B9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747669-97E8-4980-0F9D-18A272DFF5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3CC56-42FD-CF40-A71F-C19DE595C6B7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B36B06-09C7-2F69-D486-F728EAAE66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FA0BA5-495C-25F3-558C-19881CD109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6BEE9-4D04-DE47-96E5-309095A37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8008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83EE3B-9AFA-5104-0976-C9AAE05C0C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FD01D0-3141-CBFE-FC0F-642D7850F0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A47158F-12AB-59AA-2E1A-0C17884C5C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CEED0E5-5686-8C65-33FC-67E16497D2B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C0FFEC-3F31-9B51-2403-2315135C93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9946342-5171-959A-50EA-9B1EE2F57D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3CC56-42FD-CF40-A71F-C19DE595C6B7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C832A97-EDA2-54EF-5138-8E654ED5E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AC10ADE-03E4-63C9-9C10-C903B99354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6BEE9-4D04-DE47-96E5-309095A37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293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59A11D-C18F-9DEB-F332-0B5CD0D994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7BD4CB9-8DBF-536E-1471-86AEBA660E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3CC56-42FD-CF40-A71F-C19DE595C6B7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CCD788F-BB30-A45E-6683-4E94AFBEE3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113342-EB57-748D-128B-82572CBFF4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6BEE9-4D04-DE47-96E5-309095A37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1821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1EF305-EC6E-506D-6746-61A675CCF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3CC56-42FD-CF40-A71F-C19DE595C6B7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59DCDE7-9E54-3E59-29BF-A85C0C555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92304BA-365A-E0DE-C16B-FACF1B430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6BEE9-4D04-DE47-96E5-309095A37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440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BF829F-788F-AC0E-AFEB-A89A826486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C0C20F-5D7B-05DB-D1EA-50727D004F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2A9C826-6203-8AF5-AAEB-3FDD0C1673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46D92A-0F1F-83F6-FA71-E68794C901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3CC56-42FD-CF40-A71F-C19DE595C6B7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CF41F7-4170-E5E0-E1D6-E41B25AFEF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77743C-62BB-8821-C24A-14B8EAB30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6BEE9-4D04-DE47-96E5-309095A37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198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561AB3-254D-AED6-E812-87A174714B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DF693B8-2842-73AF-977D-F5F69AFD12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7966EA-EABC-8CC8-EA99-5A28BDD057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F98F54-CAFC-76F4-D6CB-56767BBB4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3CC56-42FD-CF40-A71F-C19DE595C6B7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D734D1-5048-3C44-A03A-207D4A2472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623F5E-04BF-CA6B-B39A-3DE5F0D04D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C6BEE9-4D04-DE47-96E5-309095A37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909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 /><Relationship Id="rId3" Type="http://schemas.openxmlformats.org/officeDocument/2006/relationships/slideLayout" Target="../slideLayouts/slideLayout3.xml" /><Relationship Id="rId7" Type="http://schemas.openxmlformats.org/officeDocument/2006/relationships/slideLayout" Target="../slideLayouts/slideLayout7.xml" /><Relationship Id="rId12" Type="http://schemas.openxmlformats.org/officeDocument/2006/relationships/theme" Target="../theme/theme1.xml" /><Relationship Id="rId2" Type="http://schemas.openxmlformats.org/officeDocument/2006/relationships/slideLayout" Target="../slideLayouts/slideLayout2.xml" /><Relationship Id="rId1" Type="http://schemas.openxmlformats.org/officeDocument/2006/relationships/slideLayout" Target="../slideLayouts/slideLayout1.xml" /><Relationship Id="rId6" Type="http://schemas.openxmlformats.org/officeDocument/2006/relationships/slideLayout" Target="../slideLayouts/slideLayout6.xml" /><Relationship Id="rId11" Type="http://schemas.openxmlformats.org/officeDocument/2006/relationships/slideLayout" Target="../slideLayouts/slideLayout11.xml" /><Relationship Id="rId5" Type="http://schemas.openxmlformats.org/officeDocument/2006/relationships/slideLayout" Target="../slideLayouts/slideLayout5.xml" /><Relationship Id="rId10" Type="http://schemas.openxmlformats.org/officeDocument/2006/relationships/slideLayout" Target="../slideLayouts/slideLayout10.xml" /><Relationship Id="rId4" Type="http://schemas.openxmlformats.org/officeDocument/2006/relationships/slideLayout" Target="../slideLayouts/slideLayout4.xml" /><Relationship Id="rId9" Type="http://schemas.openxmlformats.org/officeDocument/2006/relationships/slideLayout" Target="../slideLayouts/slideLayout9.xml" 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1ACB6E-7980-4D02-2DE8-C84D6C7706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0A4C91-0115-55F6-F293-A8076E2F91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B46F75-5CFF-7F07-89B1-8D937D16E48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53CC56-42FD-CF40-A71F-C19DE595C6B7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DCDC29-2B0E-4335-6C40-00823F740F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B69B4A-D42F-1CAE-1FC3-CC13FD13995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C6BEE9-4D04-DE47-96E5-309095A37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928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 /><Relationship Id="rId2" Type="http://schemas.openxmlformats.org/officeDocument/2006/relationships/video" Target="../media/media1.mp4" /><Relationship Id="rId1" Type="http://schemas.microsoft.com/office/2007/relationships/media" Target="../media/media1.mp4" /><Relationship Id="rId4" Type="http://schemas.openxmlformats.org/officeDocument/2006/relationships/image" Target="../media/image1.png" 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 /><Relationship Id="rId2" Type="http://schemas.openxmlformats.org/officeDocument/2006/relationships/video" Target="../media/media2.mp4" /><Relationship Id="rId1" Type="http://schemas.microsoft.com/office/2007/relationships/media" Target="../media/media2.mp4" /><Relationship Id="rId4" Type="http://schemas.openxmlformats.org/officeDocument/2006/relationships/image" Target="../media/image2.png" 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4E37A7-E8AC-8940-8113-D6F2EA4BD6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Video 1. Coronary angiography showing normal RCA</a:t>
            </a:r>
            <a:endParaRPr lang="en-US" dirty="0"/>
          </a:p>
        </p:txBody>
      </p:sp>
      <p:pic>
        <p:nvPicPr>
          <p:cNvPr id="4" name="YouCut_20240306_132618462.mp4">
            <a:hlinkClick r:id="" action="ppaction://media"/>
            <a:extLst>
              <a:ext uri="{FF2B5EF4-FFF2-40B4-BE49-F238E27FC236}">
                <a16:creationId xmlns:a16="http://schemas.microsoft.com/office/drawing/2014/main" id="{05154B8C-8E39-D540-F2C9-E8A2343E4284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554940" y="1825624"/>
            <a:ext cx="6723531" cy="5032375"/>
          </a:xfrm>
        </p:spPr>
      </p:pic>
    </p:spTree>
    <p:extLst>
      <p:ext uri="{BB962C8B-B14F-4D97-AF65-F5344CB8AC3E}">
        <p14:creationId xmlns:p14="http://schemas.microsoft.com/office/powerpoint/2010/main" val="3756169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1AF242-4264-C547-B3A3-7A5156082F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Video 2. Coronary angiography showing normal LCX and LAD.</a:t>
            </a:r>
            <a:endParaRPr lang="en-US" dirty="0"/>
          </a:p>
        </p:txBody>
      </p:sp>
      <p:pic>
        <p:nvPicPr>
          <p:cNvPr id="4" name="YouCut_20240306_132755726.mp4">
            <a:hlinkClick r:id="" action="ppaction://media"/>
            <a:extLst>
              <a:ext uri="{FF2B5EF4-FFF2-40B4-BE49-F238E27FC236}">
                <a16:creationId xmlns:a16="http://schemas.microsoft.com/office/drawing/2014/main" id="{2B94B0CC-0FBD-EB12-C641-782079587234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153947" y="1825624"/>
            <a:ext cx="5733335" cy="5032375"/>
          </a:xfrm>
        </p:spPr>
      </p:pic>
    </p:spTree>
    <p:extLst>
      <p:ext uri="{BB962C8B-B14F-4D97-AF65-F5344CB8AC3E}">
        <p14:creationId xmlns:p14="http://schemas.microsoft.com/office/powerpoint/2010/main" val="391676448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Application>Microsoft Office PowerPoint</Application>
  <PresentationFormat>Widescreen</PresentationFormat>
  <Slides>2</Slides>
  <Notes>0</Notes>
  <HiddenSlides>0</HiddenSlide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Video 1. Coronary angiography showing normal RCA</vt:lpstr>
      <vt:lpstr>Video 2. Coronary angiography showing normal LCX and LAD.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ideo 1. Coronary angiography showing normal RCA</dc:title>
  <dc:creator>ahmed kasem</dc:creator>
  <cp:lastModifiedBy>ahmed kasem</cp:lastModifiedBy>
  <cp:revision>1</cp:revision>
  <dcterms:created xsi:type="dcterms:W3CDTF">2024-03-06T10:28:21Z</dcterms:created>
  <dcterms:modified xsi:type="dcterms:W3CDTF">2024-03-06T10:32:27Z</dcterms:modified>
</cp:coreProperties>
</file>